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10799763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94"/>
  </p:normalViewPr>
  <p:slideViewPr>
    <p:cSldViewPr snapToGrid="0" snapToObjects="1">
      <p:cViewPr varScale="1">
        <p:scale>
          <a:sx n="87" d="100"/>
          <a:sy n="87" d="100"/>
        </p:scale>
        <p:origin x="19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414125"/>
            <a:ext cx="9179799" cy="3008266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538401"/>
            <a:ext cx="8099822" cy="2086184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2132462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2699418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60041"/>
            <a:ext cx="2328699" cy="732264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60041"/>
            <a:ext cx="6851100" cy="732264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818937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1241294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154193"/>
            <a:ext cx="9314796" cy="359431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5782513"/>
            <a:ext cx="9314796" cy="189016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3298330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300203"/>
            <a:ext cx="4589899" cy="548248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300203"/>
            <a:ext cx="4589899" cy="548248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4279674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60043"/>
            <a:ext cx="9314796" cy="1670148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118188"/>
            <a:ext cx="4568805" cy="1038091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156278"/>
            <a:ext cx="4568805" cy="46424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118188"/>
            <a:ext cx="4591306" cy="1038091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156278"/>
            <a:ext cx="4591306" cy="46424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2739696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583160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892361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76051"/>
            <a:ext cx="3483205" cy="2016178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244112"/>
            <a:ext cx="5467380" cy="6140542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592229"/>
            <a:ext cx="3483205" cy="4802425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1003763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76051"/>
            <a:ext cx="3483205" cy="2016178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244112"/>
            <a:ext cx="5467380" cy="6140542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592229"/>
            <a:ext cx="3483205" cy="4802425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2322681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60043"/>
            <a:ext cx="9314796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300203"/>
            <a:ext cx="9314796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008709"/>
            <a:ext cx="2429947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7FF51-4804-2E4D-BD88-493DC9B33417}" type="datetimeFigureOut">
              <a:rPr lang="en-BG" smtClean="0"/>
              <a:t>27.09.21</a:t>
            </a:fld>
            <a:endParaRPr lang="en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008709"/>
            <a:ext cx="364492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008709"/>
            <a:ext cx="2429947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FA144A-5C79-9C46-87D5-9F10CF529060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4124221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2CD262EE-759A-2547-B3BB-C129F395B7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968" b="-1"/>
          <a:stretch/>
        </p:blipFill>
        <p:spPr>
          <a:xfrm>
            <a:off x="486870" y="213109"/>
            <a:ext cx="2326708" cy="214857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439F437-636C-774D-8DE1-5670EF2384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08591" y="181479"/>
            <a:ext cx="2406115" cy="219965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84A6405-3E2C-BD47-843F-8C0C81D99C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54984" y="175728"/>
            <a:ext cx="2342587" cy="219965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B82FD24-E004-1B41-BAC3-0C5025D30E1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893" r="2881" b="991"/>
          <a:stretch/>
        </p:blipFill>
        <p:spPr>
          <a:xfrm>
            <a:off x="523574" y="2669136"/>
            <a:ext cx="2255320" cy="222564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364E96F-79DF-DC48-A31C-6DF768FE047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55" t="2098" r="-1" b="1"/>
          <a:stretch/>
        </p:blipFill>
        <p:spPr>
          <a:xfrm>
            <a:off x="7873491" y="213109"/>
            <a:ext cx="2310852" cy="215350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A14A42A-5B61-2D49-B1BB-F993EBD04184}"/>
              </a:ext>
            </a:extLst>
          </p:cNvPr>
          <p:cNvSpPr txBox="1"/>
          <p:nvPr/>
        </p:nvSpPr>
        <p:spPr>
          <a:xfrm>
            <a:off x="3332576" y="2872288"/>
            <a:ext cx="1225953" cy="337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594" dirty="0"/>
              <a:t>150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85D9B1C-B5EA-994D-8E2F-B00F5195159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" b="2771"/>
          <a:stretch/>
        </p:blipFill>
        <p:spPr>
          <a:xfrm>
            <a:off x="2981891" y="2669136"/>
            <a:ext cx="2322234" cy="208676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03B5D7C-FAB7-E747-A023-F235A66DF0D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5663"/>
          <a:stretch/>
        </p:blipFill>
        <p:spPr>
          <a:xfrm>
            <a:off x="5345357" y="2669137"/>
            <a:ext cx="2365166" cy="204578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1F7156B-DAD7-7F4D-B4F8-BDF068DE607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3574" y="5153754"/>
            <a:ext cx="2290004" cy="213725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E0B8629-3875-494E-8F63-5D044DB0AA1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430" b="5597"/>
          <a:stretch/>
        </p:blipFill>
        <p:spPr>
          <a:xfrm>
            <a:off x="7816380" y="2700271"/>
            <a:ext cx="2365166" cy="202473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544341C-3916-BD43-8EC6-16DADA4DC86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904096" y="5193439"/>
            <a:ext cx="2388868" cy="214625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2B53E302-33E6-E74C-BDB0-2FA4AE9BE71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90319" y="5207293"/>
            <a:ext cx="2365166" cy="2311113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51D2D2FC-C24E-1343-8221-EA5D5B9E8A0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873491" y="5207293"/>
            <a:ext cx="2365167" cy="219171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E677A39-06D4-784F-8F60-340E09EADFF1}"/>
              </a:ext>
            </a:extLst>
          </p:cNvPr>
          <p:cNvSpPr txBox="1"/>
          <p:nvPr/>
        </p:nvSpPr>
        <p:spPr>
          <a:xfrm>
            <a:off x="2510871" y="345760"/>
            <a:ext cx="4065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83E1763-2DE2-E04C-A509-8A416C585C75}"/>
              </a:ext>
            </a:extLst>
          </p:cNvPr>
          <p:cNvSpPr txBox="1"/>
          <p:nvPr/>
        </p:nvSpPr>
        <p:spPr>
          <a:xfrm>
            <a:off x="4955888" y="345760"/>
            <a:ext cx="4065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B4EB275-E605-374B-BA90-D08FCDD81B5D}"/>
              </a:ext>
            </a:extLst>
          </p:cNvPr>
          <p:cNvSpPr txBox="1"/>
          <p:nvPr/>
        </p:nvSpPr>
        <p:spPr>
          <a:xfrm>
            <a:off x="7374454" y="345760"/>
            <a:ext cx="4065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0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C209F265-D9B0-2C41-A74A-92D91575FA5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712178" y="2334013"/>
            <a:ext cx="2101400" cy="16538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CEBB1CD-FB82-9C45-84C0-2D74BD63F84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3151060" y="2334013"/>
            <a:ext cx="2101400" cy="16538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8A91720-086C-0045-9B2A-AAC6CAFAD574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5526424" y="2347772"/>
            <a:ext cx="2101400" cy="165387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2E63EC3B-F960-DF48-8A33-DC3BEEDFB7E1}"/>
              </a:ext>
            </a:extLst>
          </p:cNvPr>
          <p:cNvSpPr txBox="1"/>
          <p:nvPr/>
        </p:nvSpPr>
        <p:spPr>
          <a:xfrm>
            <a:off x="9822055" y="377660"/>
            <a:ext cx="4065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0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40E4B703-F918-4144-8002-68095A78D6C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8061382" y="2344092"/>
            <a:ext cx="2101400" cy="165387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13E7BD9D-B0D4-6944-89B7-A34C1860EC15}"/>
              </a:ext>
            </a:extLst>
          </p:cNvPr>
          <p:cNvSpPr txBox="1"/>
          <p:nvPr/>
        </p:nvSpPr>
        <p:spPr>
          <a:xfrm>
            <a:off x="2497593" y="2854692"/>
            <a:ext cx="4065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B4CF93F-440B-C74F-AE09-AA5B10D27DA5}"/>
              </a:ext>
            </a:extLst>
          </p:cNvPr>
          <p:cNvSpPr txBox="1"/>
          <p:nvPr/>
        </p:nvSpPr>
        <p:spPr>
          <a:xfrm>
            <a:off x="4864448" y="2854692"/>
            <a:ext cx="45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1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7DD393A-F469-D24E-A514-AEA4AC5D1CC8}"/>
              </a:ext>
            </a:extLst>
          </p:cNvPr>
          <p:cNvSpPr txBox="1"/>
          <p:nvPr/>
        </p:nvSpPr>
        <p:spPr>
          <a:xfrm>
            <a:off x="7291795" y="2854692"/>
            <a:ext cx="45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1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97408CF-38EE-F049-9C03-868001D5BC20}"/>
              </a:ext>
            </a:extLst>
          </p:cNvPr>
          <p:cNvSpPr txBox="1"/>
          <p:nvPr/>
        </p:nvSpPr>
        <p:spPr>
          <a:xfrm>
            <a:off x="9729302" y="2854692"/>
            <a:ext cx="45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12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7A5152C9-A449-FB4D-9AD4-1C498A4C27D5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3131758" y="4759998"/>
            <a:ext cx="2101400" cy="165387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87279072-51FA-5F4C-A8B4-562506220AF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5598562" y="4757453"/>
            <a:ext cx="2101400" cy="16538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81BBA5A3-3F76-9444-91D1-1E18330C056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8021760" y="4755901"/>
            <a:ext cx="2101400" cy="165387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B5A6E87C-11BA-F74B-9245-B4DF9261F576}"/>
              </a:ext>
            </a:extLst>
          </p:cNvPr>
          <p:cNvSpPr txBox="1"/>
          <p:nvPr/>
        </p:nvSpPr>
        <p:spPr>
          <a:xfrm>
            <a:off x="2392959" y="5350414"/>
            <a:ext cx="45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1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2BAA06E-061C-6A46-AB6B-217217614566}"/>
              </a:ext>
            </a:extLst>
          </p:cNvPr>
          <p:cNvSpPr txBox="1"/>
          <p:nvPr/>
        </p:nvSpPr>
        <p:spPr>
          <a:xfrm>
            <a:off x="4913978" y="5363386"/>
            <a:ext cx="45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48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A69BDB0-B755-E741-8871-675ECB9FC50D}"/>
              </a:ext>
            </a:extLst>
          </p:cNvPr>
          <p:cNvSpPr txBox="1"/>
          <p:nvPr/>
        </p:nvSpPr>
        <p:spPr>
          <a:xfrm>
            <a:off x="7384587" y="5415209"/>
            <a:ext cx="45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48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FA55447-D258-3A49-86A6-01A0A6D74091}"/>
              </a:ext>
            </a:extLst>
          </p:cNvPr>
          <p:cNvSpPr txBox="1"/>
          <p:nvPr/>
        </p:nvSpPr>
        <p:spPr>
          <a:xfrm>
            <a:off x="9855196" y="5467032"/>
            <a:ext cx="45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dirty="0"/>
              <a:t>t96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A7AE1269-CC3C-374E-8A78-A9084C837D25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3160126" y="7307621"/>
            <a:ext cx="2101400" cy="165387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8BCBCD66-2106-7F45-8898-B264FCB873A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8079156" y="7347068"/>
            <a:ext cx="2101400" cy="165387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6352A3CF-1D3A-9E4F-B661-C971F2FFD5C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712" t="91358" b="396"/>
          <a:stretch/>
        </p:blipFill>
        <p:spPr>
          <a:xfrm>
            <a:off x="668636" y="7307620"/>
            <a:ext cx="2101400" cy="165387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2969C87B-BD34-0143-801D-E03684AA9512}"/>
              </a:ext>
            </a:extLst>
          </p:cNvPr>
          <p:cNvSpPr txBox="1"/>
          <p:nvPr/>
        </p:nvSpPr>
        <p:spPr>
          <a:xfrm>
            <a:off x="543029" y="7744683"/>
            <a:ext cx="89783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b="1" dirty="0">
                <a:latin typeface="Arial Narrow" panose="020B0606020202030204" pitchFamily="34" charset="0"/>
              </a:rPr>
              <a:t>Supplementary Figure 6</a:t>
            </a:r>
            <a:r>
              <a:rPr lang="en-BG" sz="1400" dirty="0">
                <a:latin typeface="Arial Narrow" panose="020B0606020202030204" pitchFamily="34" charset="0"/>
              </a:rPr>
              <a:t>. Signifcant cis-scReQTL between scSNVs and the expression of their harbouring gene.</a:t>
            </a:r>
          </a:p>
        </p:txBody>
      </p:sp>
    </p:spTree>
    <p:extLst>
      <p:ext uri="{BB962C8B-B14F-4D97-AF65-F5344CB8AC3E}">
        <p14:creationId xmlns:p14="http://schemas.microsoft.com/office/powerpoint/2010/main" val="66036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9</TotalTime>
  <Words>29</Words>
  <Application>Microsoft Macintosh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rvath, Anelia Dafinova</dc:creator>
  <cp:lastModifiedBy>Horvath, Anelia Dafinova</cp:lastModifiedBy>
  <cp:revision>9</cp:revision>
  <dcterms:created xsi:type="dcterms:W3CDTF">2021-06-06T15:48:40Z</dcterms:created>
  <dcterms:modified xsi:type="dcterms:W3CDTF">2021-09-27T13:44:55Z</dcterms:modified>
</cp:coreProperties>
</file>